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  <p:sldId id="273" r:id="rId3"/>
    <p:sldId id="274" r:id="rId4"/>
    <p:sldId id="280" r:id="rId5"/>
    <p:sldId id="279" r:id="rId6"/>
    <p:sldId id="270" r:id="rId7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3081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271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308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047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394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4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117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066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042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694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692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911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2FCB9-9407-4E79-B42D-E91848C70498}" type="datetimeFigureOut">
              <a:rPr lang="en-US" smtClean="0"/>
              <a:t>10/1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A3E3E-7413-4A28-9D0B-AE85D9F43D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627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7" Type="http://schemas.openxmlformats.org/officeDocument/2006/relationships/image" Target="../media/image9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8.wmf"/><Relationship Id="rId4" Type="http://schemas.openxmlformats.org/officeDocument/2006/relationships/oleObject" Target="../embeddings/oleObject2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tif"/><Relationship Id="rId4" Type="http://schemas.openxmlformats.org/officeDocument/2006/relationships/image" Target="../media/image1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26CDB35-1BE6-1482-468B-554764B9E9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541" y="604744"/>
            <a:ext cx="6096000" cy="36195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1A2981A-F293-F779-0EE4-A1A63AB83753}"/>
              </a:ext>
            </a:extLst>
          </p:cNvPr>
          <p:cNvSpPr txBox="1"/>
          <p:nvPr/>
        </p:nvSpPr>
        <p:spPr>
          <a:xfrm>
            <a:off x="613546" y="5164923"/>
            <a:ext cx="59536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. Chemical formula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mage was taken from Sigma Aldrich website. Related to Figure 3.</a:t>
            </a:r>
          </a:p>
        </p:txBody>
      </p:sp>
    </p:spTree>
    <p:extLst>
      <p:ext uri="{BB962C8B-B14F-4D97-AF65-F5344CB8AC3E}">
        <p14:creationId xmlns:p14="http://schemas.microsoft.com/office/powerpoint/2010/main" val="7078008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outdoor object, web&#10;&#10;Description automatically generated">
            <a:extLst>
              <a:ext uri="{FF2B5EF4-FFF2-40B4-BE49-F238E27FC236}">
                <a16:creationId xmlns:a16="http://schemas.microsoft.com/office/drawing/2014/main" id="{65CE8D6A-E39C-CA92-DFD4-7059E98652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224" y="470434"/>
            <a:ext cx="2624328" cy="2331720"/>
          </a:xfrm>
          <a:prstGeom prst="rect">
            <a:avLst/>
          </a:prstGeom>
        </p:spPr>
      </p:pic>
      <p:pic>
        <p:nvPicPr>
          <p:cNvPr id="5" name="Picture 4" descr="A picture containing outdoor object&#10;&#10;Description automatically generated">
            <a:extLst>
              <a:ext uri="{FF2B5EF4-FFF2-40B4-BE49-F238E27FC236}">
                <a16:creationId xmlns:a16="http://schemas.microsoft.com/office/drawing/2014/main" id="{AC603496-3447-3832-2120-2729A8B23B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470434"/>
            <a:ext cx="2624328" cy="23317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AD07771-156D-2595-0858-09F9D1884660}"/>
              </a:ext>
            </a:extLst>
          </p:cNvPr>
          <p:cNvSpPr txBox="1"/>
          <p:nvPr/>
        </p:nvSpPr>
        <p:spPr>
          <a:xfrm>
            <a:off x="452181" y="3242858"/>
            <a:ext cx="59536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. Segmented binary image (mitochondria in white) of HAP 1 WT cell before (A) and after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 µM) addition. Note the decrease of mitochondrial area in panel B representing the decrease of mitochondrial RI and thus permeabilization. The images correspond to the holographic and fluorescent images in figure 3 A-D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609F713-7D86-3EA1-7A38-AF99C6F0CC4C}"/>
              </a:ext>
            </a:extLst>
          </p:cNvPr>
          <p:cNvSpPr txBox="1"/>
          <p:nvPr/>
        </p:nvSpPr>
        <p:spPr>
          <a:xfrm>
            <a:off x="661224" y="4704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D73F8C-F44E-AFCB-5726-6C544839A913}"/>
              </a:ext>
            </a:extLst>
          </p:cNvPr>
          <p:cNvSpPr txBox="1"/>
          <p:nvPr/>
        </p:nvSpPr>
        <p:spPr>
          <a:xfrm>
            <a:off x="3438205" y="4704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6383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F164342-4916-B009-F6C3-9BE701CCBBF4}"/>
              </a:ext>
            </a:extLst>
          </p:cNvPr>
          <p:cNvSpPr txBox="1"/>
          <p:nvPr/>
        </p:nvSpPr>
        <p:spPr>
          <a:xfrm>
            <a:off x="220533" y="5535168"/>
            <a:ext cx="63954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3. Mitochondrial area remained on holographic reconstructions after depolarization with 20 µM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TP induction) and with 10 µM of  FCCP (PT independent depolarization)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***p&lt;0.001. Related to Figure 3 K-O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ACADCBE-982F-D11C-446F-DE094D4BBB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5384"/>
            <a:ext cx="6837574" cy="52356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93936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B9B8AC6-CA68-4BE5-BC68-4B6D87C154E7}"/>
              </a:ext>
            </a:extLst>
          </p:cNvPr>
          <p:cNvSpPr txBox="1"/>
          <p:nvPr/>
        </p:nvSpPr>
        <p:spPr>
          <a:xfrm>
            <a:off x="452181" y="4034731"/>
            <a:ext cx="595363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4. TMRM fluorescent signal  in HAP 1 WT and HAP 1 Δ(c+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out normalization. A. TMRM signal in HAP1 Δ(c+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lower when compared to the TMRM signal in HAP 1 WT cells. Representative traces correspond to the normalized TMRM traces in figure 3E for HAP1 WT cells and  figure 4E for HAP 1 Δ(c+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. TMRM signal afte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ddition in presence or absence of CSA (2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raw values correspond to the normalized values of TMRM presented on the figure 4F. Note that despite the lower initial level of TMRM signal on panel A, HAP 1 Δ(c+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ndergo CSA sensitive depolarization upo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treatment. One Way ANOVA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***p&lt;0.001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A814773-4688-AE6F-D131-17D7F167F1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2494"/>
            <a:ext cx="4233004" cy="32392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1E807E9-FD4B-D91F-B01E-A8DB85DD800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31" r="42919"/>
          <a:stretch/>
        </p:blipFill>
        <p:spPr>
          <a:xfrm>
            <a:off x="3918810" y="178970"/>
            <a:ext cx="2422702" cy="374159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C7CE27A-E98E-F8FD-C524-465791665F38}"/>
              </a:ext>
            </a:extLst>
          </p:cNvPr>
          <p:cNvSpPr txBox="1"/>
          <p:nvPr/>
        </p:nvSpPr>
        <p:spPr>
          <a:xfrm>
            <a:off x="256989" y="2683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0C53A06-8628-368A-277C-3F9E919869D3}"/>
              </a:ext>
            </a:extLst>
          </p:cNvPr>
          <p:cNvSpPr txBox="1"/>
          <p:nvPr/>
        </p:nvSpPr>
        <p:spPr>
          <a:xfrm>
            <a:off x="3759952" y="2683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14883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4878833-0B33-290A-B1EB-89C25E2797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1372006"/>
              </p:ext>
            </p:extLst>
          </p:nvPr>
        </p:nvGraphicFramePr>
        <p:xfrm>
          <a:off x="0" y="430307"/>
          <a:ext cx="3468120" cy="2629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9802440" imgH="7502760" progId="Origin95.Graph">
                  <p:embed/>
                </p:oleObj>
              </mc:Choice>
              <mc:Fallback>
                <p:oleObj name="Graph" r:id="rId2" imgW="9802440" imgH="7502760" progId="Origin95.Graph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F9ECA8A-7B84-63BC-1370-62A5E86403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430307"/>
                        <a:ext cx="3468120" cy="2629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103B47E-B0D3-4DEE-7F99-588BE974CE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1183605"/>
              </p:ext>
            </p:extLst>
          </p:nvPr>
        </p:nvGraphicFramePr>
        <p:xfrm>
          <a:off x="3525273" y="430307"/>
          <a:ext cx="3468120" cy="2629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9802440" imgH="7502760" progId="Origin95.Graph">
                  <p:embed/>
                </p:oleObj>
              </mc:Choice>
              <mc:Fallback>
                <p:oleObj name="Graph" r:id="rId4" imgW="9802440" imgH="7502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A3AF7D8-83F1-6E9F-DA2A-9212E63144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25273" y="430307"/>
                        <a:ext cx="3468120" cy="2629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2397D2C-BB7A-315D-2D3B-F7E99EF025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3958074"/>
              </p:ext>
            </p:extLst>
          </p:nvPr>
        </p:nvGraphicFramePr>
        <p:xfrm>
          <a:off x="0" y="3359201"/>
          <a:ext cx="3435625" cy="2629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9802440" imgH="7502760" progId="Origin95.Graph">
                  <p:embed/>
                </p:oleObj>
              </mc:Choice>
              <mc:Fallback>
                <p:oleObj name="Graph" r:id="rId6" imgW="9802440" imgH="7502760" progId="Origin95.Graph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1DE2F287-4E6B-4C62-A65A-AC7F4C7D69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0" y="3359201"/>
                        <a:ext cx="3435625" cy="2629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1467BE5-4B48-60E4-6602-F66ACB297770}"/>
              </a:ext>
            </a:extLst>
          </p:cNvPr>
          <p:cNvSpPr txBox="1"/>
          <p:nvPr/>
        </p:nvSpPr>
        <p:spPr>
          <a:xfrm>
            <a:off x="387874" y="6270273"/>
            <a:ext cx="595363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5. A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0 µM) induced depolarization of mitochondria in MEF WT cells. Representative TMRM and Fluo-4 trace indicating membrane potential and cytoplasmic calcium concentration respectively; n=10. B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 µM) block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duced depolarization. Representative experiment; n=18. On A and B note release of calcium from mitochondria upon full depolarization. C. TMRM signal at the 60% depolarization timepoint (N=3 experiments; n=104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=114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tinin+Cs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-Test. Related to Figure 6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85AF15E-D650-8E70-1688-153D9FBAB9BF}"/>
              </a:ext>
            </a:extLst>
          </p:cNvPr>
          <p:cNvSpPr txBox="1"/>
          <p:nvPr/>
        </p:nvSpPr>
        <p:spPr>
          <a:xfrm>
            <a:off x="149412" y="2683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732D894-F8D0-FE5C-0920-33D39594287D}"/>
              </a:ext>
            </a:extLst>
          </p:cNvPr>
          <p:cNvSpPr txBox="1"/>
          <p:nvPr/>
        </p:nvSpPr>
        <p:spPr>
          <a:xfrm>
            <a:off x="3365918" y="2683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71BDC7-2FD2-5F1B-108C-5D77577903E8}"/>
              </a:ext>
            </a:extLst>
          </p:cNvPr>
          <p:cNvSpPr txBox="1"/>
          <p:nvPr/>
        </p:nvSpPr>
        <p:spPr>
          <a:xfrm>
            <a:off x="159030" y="322172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797375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indoor, honeycomb, pomegranate, close&#10;&#10;Description automatically generated">
            <a:extLst>
              <a:ext uri="{FF2B5EF4-FFF2-40B4-BE49-F238E27FC236}">
                <a16:creationId xmlns:a16="http://schemas.microsoft.com/office/drawing/2014/main" id="{732606FB-18CE-4A56-869E-6F9F3ACC58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070" y="337651"/>
            <a:ext cx="2788373" cy="278837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91BEC73-C0B0-4E9A-890D-E7361F72DC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37651"/>
            <a:ext cx="2788373" cy="2788373"/>
          </a:xfrm>
          <a:prstGeom prst="rect">
            <a:avLst/>
          </a:prstGeom>
        </p:spPr>
      </p:pic>
      <p:pic>
        <p:nvPicPr>
          <p:cNvPr id="9" name="Picture 8" descr="A black and white drawing of a tree&#10;&#10;Description automatically generated with low confidence">
            <a:extLst>
              <a:ext uri="{FF2B5EF4-FFF2-40B4-BE49-F238E27FC236}">
                <a16:creationId xmlns:a16="http://schemas.microsoft.com/office/drawing/2014/main" id="{666A17B2-A08E-4DD7-BCAC-D1369EC5F8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070" y="3438581"/>
            <a:ext cx="2788373" cy="2788373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11" name="Picture 10" descr="A close up of a fire&#10;&#10;Description automatically generated with low confidence">
            <a:extLst>
              <a:ext uri="{FF2B5EF4-FFF2-40B4-BE49-F238E27FC236}">
                <a16:creationId xmlns:a16="http://schemas.microsoft.com/office/drawing/2014/main" id="{1E7E792A-859E-4E57-B2DB-25AF78B66C6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382002"/>
            <a:ext cx="2844952" cy="284495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DD87995-DB55-43EF-A789-77900E298323}"/>
              </a:ext>
            </a:extLst>
          </p:cNvPr>
          <p:cNvSpPr txBox="1"/>
          <p:nvPr/>
        </p:nvSpPr>
        <p:spPr>
          <a:xfrm>
            <a:off x="542070" y="337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D6DECE-BB23-4231-812F-FA97231E7279}"/>
              </a:ext>
            </a:extLst>
          </p:cNvPr>
          <p:cNvSpPr txBox="1"/>
          <p:nvPr/>
        </p:nvSpPr>
        <p:spPr>
          <a:xfrm>
            <a:off x="3429000" y="337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6C5EA5C-C336-472D-AF0F-B0BA9B9E0E7A}"/>
              </a:ext>
            </a:extLst>
          </p:cNvPr>
          <p:cNvSpPr txBox="1"/>
          <p:nvPr/>
        </p:nvSpPr>
        <p:spPr>
          <a:xfrm>
            <a:off x="3430509" y="338200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E046438-1949-4483-AAF8-EEDDBD953209}"/>
              </a:ext>
            </a:extLst>
          </p:cNvPr>
          <p:cNvSpPr txBox="1"/>
          <p:nvPr/>
        </p:nvSpPr>
        <p:spPr>
          <a:xfrm>
            <a:off x="542070" y="34440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583A32-D629-4ADE-A778-94DF54CD8DAD}"/>
              </a:ext>
            </a:extLst>
          </p:cNvPr>
          <p:cNvSpPr txBox="1"/>
          <p:nvPr/>
        </p:nvSpPr>
        <p:spPr>
          <a:xfrm>
            <a:off x="452181" y="6539511"/>
            <a:ext cx="59536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6 A. Holographic (RI) image of the WT HAP 1 cells; B. Probability map creat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asti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. Segmented binary image (mitochondria in black); D. Fluorescent image labeled with TMRM that was used for the selection of regions with functional mitochondria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line shows representative ROI selection. Related to Figure 2.</a:t>
            </a:r>
          </a:p>
        </p:txBody>
      </p:sp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A4DA0DC0-A83F-4623-BC68-0980FE757963}"/>
              </a:ext>
            </a:extLst>
          </p:cNvPr>
          <p:cNvSpPr/>
          <p:nvPr/>
        </p:nvSpPr>
        <p:spPr>
          <a:xfrm>
            <a:off x="5305710" y="4736212"/>
            <a:ext cx="301150" cy="169790"/>
          </a:xfrm>
          <a:custGeom>
            <a:avLst/>
            <a:gdLst>
              <a:gd name="connsiteX0" fmla="*/ 5476 w 301150"/>
              <a:gd name="connsiteY0" fmla="*/ 5527 h 169790"/>
              <a:gd name="connsiteX1" fmla="*/ 114985 w 301150"/>
              <a:gd name="connsiteY1" fmla="*/ 11002 h 169790"/>
              <a:gd name="connsiteX2" fmla="*/ 153313 w 301150"/>
              <a:gd name="connsiteY2" fmla="*/ 49331 h 169790"/>
              <a:gd name="connsiteX3" fmla="*/ 169739 w 301150"/>
              <a:gd name="connsiteY3" fmla="*/ 54806 h 169790"/>
              <a:gd name="connsiteX4" fmla="*/ 208067 w 301150"/>
              <a:gd name="connsiteY4" fmla="*/ 49331 h 169790"/>
              <a:gd name="connsiteX5" fmla="*/ 224494 w 301150"/>
              <a:gd name="connsiteY5" fmla="*/ 38380 h 169790"/>
              <a:gd name="connsiteX6" fmla="*/ 246395 w 301150"/>
              <a:gd name="connsiteY6" fmla="*/ 27429 h 169790"/>
              <a:gd name="connsiteX7" fmla="*/ 268297 w 301150"/>
              <a:gd name="connsiteY7" fmla="*/ 51 h 169790"/>
              <a:gd name="connsiteX8" fmla="*/ 301150 w 301150"/>
              <a:gd name="connsiteY8" fmla="*/ 43855 h 169790"/>
              <a:gd name="connsiteX9" fmla="*/ 284724 w 301150"/>
              <a:gd name="connsiteY9" fmla="*/ 104085 h 169790"/>
              <a:gd name="connsiteX10" fmla="*/ 229969 w 301150"/>
              <a:gd name="connsiteY10" fmla="*/ 125987 h 169790"/>
              <a:gd name="connsiteX11" fmla="*/ 219018 w 301150"/>
              <a:gd name="connsiteY11" fmla="*/ 142413 h 169790"/>
              <a:gd name="connsiteX12" fmla="*/ 208067 w 301150"/>
              <a:gd name="connsiteY12" fmla="*/ 164315 h 169790"/>
              <a:gd name="connsiteX13" fmla="*/ 186165 w 301150"/>
              <a:gd name="connsiteY13" fmla="*/ 169790 h 169790"/>
              <a:gd name="connsiteX14" fmla="*/ 136886 w 301150"/>
              <a:gd name="connsiteY14" fmla="*/ 164315 h 169790"/>
              <a:gd name="connsiteX15" fmla="*/ 114985 w 301150"/>
              <a:gd name="connsiteY15" fmla="*/ 153364 h 169790"/>
              <a:gd name="connsiteX16" fmla="*/ 87607 w 301150"/>
              <a:gd name="connsiteY16" fmla="*/ 142413 h 169790"/>
              <a:gd name="connsiteX17" fmla="*/ 43804 w 301150"/>
              <a:gd name="connsiteY17" fmla="*/ 136938 h 169790"/>
              <a:gd name="connsiteX18" fmla="*/ 21902 w 301150"/>
              <a:gd name="connsiteY18" fmla="*/ 125987 h 169790"/>
              <a:gd name="connsiteX19" fmla="*/ 16427 w 301150"/>
              <a:gd name="connsiteY19" fmla="*/ 104085 h 169790"/>
              <a:gd name="connsiteX20" fmla="*/ 0 w 301150"/>
              <a:gd name="connsiteY20" fmla="*/ 76708 h 169790"/>
              <a:gd name="connsiteX21" fmla="*/ 10951 w 301150"/>
              <a:gd name="connsiteY21" fmla="*/ 60281 h 169790"/>
              <a:gd name="connsiteX22" fmla="*/ 5476 w 301150"/>
              <a:gd name="connsiteY22" fmla="*/ 5527 h 169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301150" h="169790">
                <a:moveTo>
                  <a:pt x="5476" y="5527"/>
                </a:moveTo>
                <a:cubicBezTo>
                  <a:pt x="22815" y="-2686"/>
                  <a:pt x="79942" y="619"/>
                  <a:pt x="114985" y="11002"/>
                </a:cubicBezTo>
                <a:cubicBezTo>
                  <a:pt x="132309" y="16135"/>
                  <a:pt x="136172" y="43618"/>
                  <a:pt x="153313" y="49331"/>
                </a:cubicBezTo>
                <a:lnTo>
                  <a:pt x="169739" y="54806"/>
                </a:lnTo>
                <a:cubicBezTo>
                  <a:pt x="182515" y="52981"/>
                  <a:pt x="195706" y="53039"/>
                  <a:pt x="208067" y="49331"/>
                </a:cubicBezTo>
                <a:cubicBezTo>
                  <a:pt x="214370" y="47440"/>
                  <a:pt x="218780" y="41645"/>
                  <a:pt x="224494" y="38380"/>
                </a:cubicBezTo>
                <a:cubicBezTo>
                  <a:pt x="231581" y="34330"/>
                  <a:pt x="239095" y="31079"/>
                  <a:pt x="246395" y="27429"/>
                </a:cubicBezTo>
                <a:cubicBezTo>
                  <a:pt x="253696" y="18303"/>
                  <a:pt x="256700" y="1501"/>
                  <a:pt x="268297" y="51"/>
                </a:cubicBezTo>
                <a:cubicBezTo>
                  <a:pt x="281320" y="-1577"/>
                  <a:pt x="297164" y="35883"/>
                  <a:pt x="301150" y="43855"/>
                </a:cubicBezTo>
                <a:cubicBezTo>
                  <a:pt x="300141" y="51926"/>
                  <a:pt x="301473" y="94314"/>
                  <a:pt x="284724" y="104085"/>
                </a:cubicBezTo>
                <a:cubicBezTo>
                  <a:pt x="267744" y="113990"/>
                  <a:pt x="229969" y="125987"/>
                  <a:pt x="229969" y="125987"/>
                </a:cubicBezTo>
                <a:cubicBezTo>
                  <a:pt x="226319" y="131462"/>
                  <a:pt x="222283" y="136699"/>
                  <a:pt x="219018" y="142413"/>
                </a:cubicBezTo>
                <a:cubicBezTo>
                  <a:pt x="214968" y="149500"/>
                  <a:pt x="214338" y="159090"/>
                  <a:pt x="208067" y="164315"/>
                </a:cubicBezTo>
                <a:cubicBezTo>
                  <a:pt x="202286" y="169133"/>
                  <a:pt x="193466" y="167965"/>
                  <a:pt x="186165" y="169790"/>
                </a:cubicBezTo>
                <a:cubicBezTo>
                  <a:pt x="169739" y="167965"/>
                  <a:pt x="152990" y="168031"/>
                  <a:pt x="136886" y="164315"/>
                </a:cubicBezTo>
                <a:cubicBezTo>
                  <a:pt x="128933" y="162480"/>
                  <a:pt x="122444" y="156679"/>
                  <a:pt x="114985" y="153364"/>
                </a:cubicBezTo>
                <a:cubicBezTo>
                  <a:pt x="106003" y="149372"/>
                  <a:pt x="97184" y="144623"/>
                  <a:pt x="87607" y="142413"/>
                </a:cubicBezTo>
                <a:cubicBezTo>
                  <a:pt x="73269" y="139104"/>
                  <a:pt x="58405" y="138763"/>
                  <a:pt x="43804" y="136938"/>
                </a:cubicBezTo>
                <a:cubicBezTo>
                  <a:pt x="36503" y="133288"/>
                  <a:pt x="27127" y="132258"/>
                  <a:pt x="21902" y="125987"/>
                </a:cubicBezTo>
                <a:cubicBezTo>
                  <a:pt x="17084" y="120206"/>
                  <a:pt x="19483" y="110962"/>
                  <a:pt x="16427" y="104085"/>
                </a:cubicBezTo>
                <a:cubicBezTo>
                  <a:pt x="12105" y="94360"/>
                  <a:pt x="5476" y="85834"/>
                  <a:pt x="0" y="76708"/>
                </a:cubicBezTo>
                <a:cubicBezTo>
                  <a:pt x="3650" y="71232"/>
                  <a:pt x="8008" y="66167"/>
                  <a:pt x="10951" y="60281"/>
                </a:cubicBezTo>
                <a:cubicBezTo>
                  <a:pt x="31792" y="18598"/>
                  <a:pt x="-11863" y="13740"/>
                  <a:pt x="5476" y="5527"/>
                </a:cubicBezTo>
                <a:close/>
              </a:path>
            </a:pathLst>
          </a:custGeom>
          <a:noFill/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reeform: Shape 18">
            <a:extLst>
              <a:ext uri="{FF2B5EF4-FFF2-40B4-BE49-F238E27FC236}">
                <a16:creationId xmlns:a16="http://schemas.microsoft.com/office/drawing/2014/main" id="{164AA8B7-CD0D-4B54-B231-560F1D44FDA3}"/>
              </a:ext>
            </a:extLst>
          </p:cNvPr>
          <p:cNvSpPr/>
          <p:nvPr/>
        </p:nvSpPr>
        <p:spPr>
          <a:xfrm>
            <a:off x="2413761" y="4752637"/>
            <a:ext cx="301150" cy="169790"/>
          </a:xfrm>
          <a:custGeom>
            <a:avLst/>
            <a:gdLst>
              <a:gd name="connsiteX0" fmla="*/ 5476 w 301150"/>
              <a:gd name="connsiteY0" fmla="*/ 5527 h 169790"/>
              <a:gd name="connsiteX1" fmla="*/ 114985 w 301150"/>
              <a:gd name="connsiteY1" fmla="*/ 11002 h 169790"/>
              <a:gd name="connsiteX2" fmla="*/ 153313 w 301150"/>
              <a:gd name="connsiteY2" fmla="*/ 49331 h 169790"/>
              <a:gd name="connsiteX3" fmla="*/ 169739 w 301150"/>
              <a:gd name="connsiteY3" fmla="*/ 54806 h 169790"/>
              <a:gd name="connsiteX4" fmla="*/ 208067 w 301150"/>
              <a:gd name="connsiteY4" fmla="*/ 49331 h 169790"/>
              <a:gd name="connsiteX5" fmla="*/ 224494 w 301150"/>
              <a:gd name="connsiteY5" fmla="*/ 38380 h 169790"/>
              <a:gd name="connsiteX6" fmla="*/ 246395 w 301150"/>
              <a:gd name="connsiteY6" fmla="*/ 27429 h 169790"/>
              <a:gd name="connsiteX7" fmla="*/ 268297 w 301150"/>
              <a:gd name="connsiteY7" fmla="*/ 51 h 169790"/>
              <a:gd name="connsiteX8" fmla="*/ 301150 w 301150"/>
              <a:gd name="connsiteY8" fmla="*/ 43855 h 169790"/>
              <a:gd name="connsiteX9" fmla="*/ 284724 w 301150"/>
              <a:gd name="connsiteY9" fmla="*/ 104085 h 169790"/>
              <a:gd name="connsiteX10" fmla="*/ 229969 w 301150"/>
              <a:gd name="connsiteY10" fmla="*/ 125987 h 169790"/>
              <a:gd name="connsiteX11" fmla="*/ 219018 w 301150"/>
              <a:gd name="connsiteY11" fmla="*/ 142413 h 169790"/>
              <a:gd name="connsiteX12" fmla="*/ 208067 w 301150"/>
              <a:gd name="connsiteY12" fmla="*/ 164315 h 169790"/>
              <a:gd name="connsiteX13" fmla="*/ 186165 w 301150"/>
              <a:gd name="connsiteY13" fmla="*/ 169790 h 169790"/>
              <a:gd name="connsiteX14" fmla="*/ 136886 w 301150"/>
              <a:gd name="connsiteY14" fmla="*/ 164315 h 169790"/>
              <a:gd name="connsiteX15" fmla="*/ 114985 w 301150"/>
              <a:gd name="connsiteY15" fmla="*/ 153364 h 169790"/>
              <a:gd name="connsiteX16" fmla="*/ 87607 w 301150"/>
              <a:gd name="connsiteY16" fmla="*/ 142413 h 169790"/>
              <a:gd name="connsiteX17" fmla="*/ 43804 w 301150"/>
              <a:gd name="connsiteY17" fmla="*/ 136938 h 169790"/>
              <a:gd name="connsiteX18" fmla="*/ 21902 w 301150"/>
              <a:gd name="connsiteY18" fmla="*/ 125987 h 169790"/>
              <a:gd name="connsiteX19" fmla="*/ 16427 w 301150"/>
              <a:gd name="connsiteY19" fmla="*/ 104085 h 169790"/>
              <a:gd name="connsiteX20" fmla="*/ 0 w 301150"/>
              <a:gd name="connsiteY20" fmla="*/ 76708 h 169790"/>
              <a:gd name="connsiteX21" fmla="*/ 10951 w 301150"/>
              <a:gd name="connsiteY21" fmla="*/ 60281 h 169790"/>
              <a:gd name="connsiteX22" fmla="*/ 5476 w 301150"/>
              <a:gd name="connsiteY22" fmla="*/ 5527 h 169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301150" h="169790">
                <a:moveTo>
                  <a:pt x="5476" y="5527"/>
                </a:moveTo>
                <a:cubicBezTo>
                  <a:pt x="22815" y="-2686"/>
                  <a:pt x="79942" y="619"/>
                  <a:pt x="114985" y="11002"/>
                </a:cubicBezTo>
                <a:cubicBezTo>
                  <a:pt x="132309" y="16135"/>
                  <a:pt x="136172" y="43618"/>
                  <a:pt x="153313" y="49331"/>
                </a:cubicBezTo>
                <a:lnTo>
                  <a:pt x="169739" y="54806"/>
                </a:lnTo>
                <a:cubicBezTo>
                  <a:pt x="182515" y="52981"/>
                  <a:pt x="195706" y="53039"/>
                  <a:pt x="208067" y="49331"/>
                </a:cubicBezTo>
                <a:cubicBezTo>
                  <a:pt x="214370" y="47440"/>
                  <a:pt x="218780" y="41645"/>
                  <a:pt x="224494" y="38380"/>
                </a:cubicBezTo>
                <a:cubicBezTo>
                  <a:pt x="231581" y="34330"/>
                  <a:pt x="239095" y="31079"/>
                  <a:pt x="246395" y="27429"/>
                </a:cubicBezTo>
                <a:cubicBezTo>
                  <a:pt x="253696" y="18303"/>
                  <a:pt x="256700" y="1501"/>
                  <a:pt x="268297" y="51"/>
                </a:cubicBezTo>
                <a:cubicBezTo>
                  <a:pt x="281320" y="-1577"/>
                  <a:pt x="297164" y="35883"/>
                  <a:pt x="301150" y="43855"/>
                </a:cubicBezTo>
                <a:cubicBezTo>
                  <a:pt x="300141" y="51926"/>
                  <a:pt x="301473" y="94314"/>
                  <a:pt x="284724" y="104085"/>
                </a:cubicBezTo>
                <a:cubicBezTo>
                  <a:pt x="267744" y="113990"/>
                  <a:pt x="229969" y="125987"/>
                  <a:pt x="229969" y="125987"/>
                </a:cubicBezTo>
                <a:cubicBezTo>
                  <a:pt x="226319" y="131462"/>
                  <a:pt x="222283" y="136699"/>
                  <a:pt x="219018" y="142413"/>
                </a:cubicBezTo>
                <a:cubicBezTo>
                  <a:pt x="214968" y="149500"/>
                  <a:pt x="214338" y="159090"/>
                  <a:pt x="208067" y="164315"/>
                </a:cubicBezTo>
                <a:cubicBezTo>
                  <a:pt x="202286" y="169133"/>
                  <a:pt x="193466" y="167965"/>
                  <a:pt x="186165" y="169790"/>
                </a:cubicBezTo>
                <a:cubicBezTo>
                  <a:pt x="169739" y="167965"/>
                  <a:pt x="152990" y="168031"/>
                  <a:pt x="136886" y="164315"/>
                </a:cubicBezTo>
                <a:cubicBezTo>
                  <a:pt x="128933" y="162480"/>
                  <a:pt x="122444" y="156679"/>
                  <a:pt x="114985" y="153364"/>
                </a:cubicBezTo>
                <a:cubicBezTo>
                  <a:pt x="106003" y="149372"/>
                  <a:pt x="97184" y="144623"/>
                  <a:pt x="87607" y="142413"/>
                </a:cubicBezTo>
                <a:cubicBezTo>
                  <a:pt x="73269" y="139104"/>
                  <a:pt x="58405" y="138763"/>
                  <a:pt x="43804" y="136938"/>
                </a:cubicBezTo>
                <a:cubicBezTo>
                  <a:pt x="36503" y="133288"/>
                  <a:pt x="27127" y="132258"/>
                  <a:pt x="21902" y="125987"/>
                </a:cubicBezTo>
                <a:cubicBezTo>
                  <a:pt x="17084" y="120206"/>
                  <a:pt x="19483" y="110962"/>
                  <a:pt x="16427" y="104085"/>
                </a:cubicBezTo>
                <a:cubicBezTo>
                  <a:pt x="12105" y="94360"/>
                  <a:pt x="5476" y="85834"/>
                  <a:pt x="0" y="76708"/>
                </a:cubicBezTo>
                <a:cubicBezTo>
                  <a:pt x="3650" y="71232"/>
                  <a:pt x="8008" y="66167"/>
                  <a:pt x="10951" y="60281"/>
                </a:cubicBezTo>
                <a:cubicBezTo>
                  <a:pt x="31792" y="18598"/>
                  <a:pt x="-11863" y="13740"/>
                  <a:pt x="5476" y="5527"/>
                </a:cubicBezTo>
                <a:close/>
              </a:path>
            </a:pathLst>
          </a:custGeom>
          <a:noFill/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758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62</TotalTime>
  <Words>484</Words>
  <Application>Microsoft Office PowerPoint</Application>
  <PresentationFormat>Letter Paper (8.5x11 in)</PresentationFormat>
  <Paragraphs>18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Мария Негинская</dc:creator>
  <cp:lastModifiedBy>Maria Neginskaya</cp:lastModifiedBy>
  <cp:revision>83</cp:revision>
  <cp:lastPrinted>2021-11-11T17:37:26Z</cp:lastPrinted>
  <dcterms:created xsi:type="dcterms:W3CDTF">2021-09-28T16:36:45Z</dcterms:created>
  <dcterms:modified xsi:type="dcterms:W3CDTF">2022-10-19T21:51:15Z</dcterms:modified>
</cp:coreProperties>
</file>